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1F6FD7B-40A2-1046-9AD6-7AA8F11CA19C}" v="1" dt="2025-02-22T20:52:15.76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382"/>
    <p:restoredTop sz="94658"/>
  </p:normalViewPr>
  <p:slideViewPr>
    <p:cSldViewPr snapToGrid="0">
      <p:cViewPr varScale="1">
        <p:scale>
          <a:sx n="92" d="100"/>
          <a:sy n="92" d="100"/>
        </p:scale>
        <p:origin x="62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mal, Abu Hena Mostafa" userId="21019849-18b7-451d-ba41-a049a0f20c98" providerId="ADAL" clId="{91F6FD7B-40A2-1046-9AD6-7AA8F11CA19C}"/>
    <pc:docChg chg="custSel addSld delSld modSld">
      <pc:chgData name="Kamal, Abu Hena Mostafa" userId="21019849-18b7-451d-ba41-a049a0f20c98" providerId="ADAL" clId="{91F6FD7B-40A2-1046-9AD6-7AA8F11CA19C}" dt="2025-02-22T20:53:46.979" v="5" actId="2696"/>
      <pc:docMkLst>
        <pc:docMk/>
      </pc:docMkLst>
      <pc:sldChg chg="delSp new del mod">
        <pc:chgData name="Kamal, Abu Hena Mostafa" userId="21019849-18b7-451d-ba41-a049a0f20c98" providerId="ADAL" clId="{91F6FD7B-40A2-1046-9AD6-7AA8F11CA19C}" dt="2025-02-22T20:52:17.647" v="4" actId="2696"/>
        <pc:sldMkLst>
          <pc:docMk/>
          <pc:sldMk cId="331672132" sldId="262"/>
        </pc:sldMkLst>
        <pc:spChg chg="del">
          <ac:chgData name="Kamal, Abu Hena Mostafa" userId="21019849-18b7-451d-ba41-a049a0f20c98" providerId="ADAL" clId="{91F6FD7B-40A2-1046-9AD6-7AA8F11CA19C}" dt="2025-02-22T20:51:51.249" v="1" actId="478"/>
          <ac:spMkLst>
            <pc:docMk/>
            <pc:sldMk cId="331672132" sldId="262"/>
            <ac:spMk id="2" creationId="{E9512FCF-D155-BF56-75AB-F5019E43F81B}"/>
          </ac:spMkLst>
        </pc:spChg>
        <pc:spChg chg="del">
          <ac:chgData name="Kamal, Abu Hena Mostafa" userId="21019849-18b7-451d-ba41-a049a0f20c98" providerId="ADAL" clId="{91F6FD7B-40A2-1046-9AD6-7AA8F11CA19C}" dt="2025-02-22T20:51:52.788" v="2" actId="478"/>
          <ac:spMkLst>
            <pc:docMk/>
            <pc:sldMk cId="331672132" sldId="262"/>
            <ac:spMk id="3" creationId="{10774C8A-9FB3-4FE2-8DCE-EE34EE98D985}"/>
          </ac:spMkLst>
        </pc:spChg>
      </pc:sldChg>
      <pc:sldChg chg="add del">
        <pc:chgData name="Kamal, Abu Hena Mostafa" userId="21019849-18b7-451d-ba41-a049a0f20c98" providerId="ADAL" clId="{91F6FD7B-40A2-1046-9AD6-7AA8F11CA19C}" dt="2025-02-22T20:53:46.979" v="5" actId="2696"/>
        <pc:sldMkLst>
          <pc:docMk/>
          <pc:sldMk cId="2263670542" sldId="263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543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379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410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38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901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487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0096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4567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098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336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274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3E04EDA-8D7D-44C9-84FB-D58C042BECE4}" type="datetimeFigureOut">
              <a:rPr lang="en-US" smtClean="0"/>
              <a:t>2/2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29B98B-35EC-4AF7-ACFC-6BB1BDCDF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668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BA9E80A-DBCB-B67B-41AE-A54FBA65E9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7303465"/>
              </p:ext>
            </p:extLst>
          </p:nvPr>
        </p:nvGraphicFramePr>
        <p:xfrm>
          <a:off x="444816" y="3402985"/>
          <a:ext cx="6058852" cy="782866"/>
        </p:xfrm>
        <a:graphic>
          <a:graphicData uri="http://schemas.openxmlformats.org/drawingml/2006/table">
            <a:tbl>
              <a:tblPr>
                <a:tableStyleId>{9DCAF9ED-07DC-4A11-8D7F-57B35C25682E}</a:tableStyleId>
              </a:tblPr>
              <a:tblGrid>
                <a:gridCol w="629302">
                  <a:extLst>
                    <a:ext uri="{9D8B030D-6E8A-4147-A177-3AD203B41FA5}">
                      <a16:colId xmlns:a16="http://schemas.microsoft.com/office/drawing/2014/main" val="594954387"/>
                    </a:ext>
                  </a:extLst>
                </a:gridCol>
                <a:gridCol w="510842">
                  <a:extLst>
                    <a:ext uri="{9D8B030D-6E8A-4147-A177-3AD203B41FA5}">
                      <a16:colId xmlns:a16="http://schemas.microsoft.com/office/drawing/2014/main" val="2564450109"/>
                    </a:ext>
                  </a:extLst>
                </a:gridCol>
                <a:gridCol w="339036">
                  <a:extLst>
                    <a:ext uri="{9D8B030D-6E8A-4147-A177-3AD203B41FA5}">
                      <a16:colId xmlns:a16="http://schemas.microsoft.com/office/drawing/2014/main" val="3985979407"/>
                    </a:ext>
                  </a:extLst>
                </a:gridCol>
                <a:gridCol w="457967">
                  <a:extLst>
                    <a:ext uri="{9D8B030D-6E8A-4147-A177-3AD203B41FA5}">
                      <a16:colId xmlns:a16="http://schemas.microsoft.com/office/drawing/2014/main" val="369052869"/>
                    </a:ext>
                  </a:extLst>
                </a:gridCol>
                <a:gridCol w="502980">
                  <a:extLst>
                    <a:ext uri="{9D8B030D-6E8A-4147-A177-3AD203B41FA5}">
                      <a16:colId xmlns:a16="http://schemas.microsoft.com/office/drawing/2014/main" val="581111272"/>
                    </a:ext>
                  </a:extLst>
                </a:gridCol>
                <a:gridCol w="412955">
                  <a:extLst>
                    <a:ext uri="{9D8B030D-6E8A-4147-A177-3AD203B41FA5}">
                      <a16:colId xmlns:a16="http://schemas.microsoft.com/office/drawing/2014/main" val="4113154576"/>
                    </a:ext>
                  </a:extLst>
                </a:gridCol>
                <a:gridCol w="457967">
                  <a:extLst>
                    <a:ext uri="{9D8B030D-6E8A-4147-A177-3AD203B41FA5}">
                      <a16:colId xmlns:a16="http://schemas.microsoft.com/office/drawing/2014/main" val="2035942599"/>
                    </a:ext>
                  </a:extLst>
                </a:gridCol>
                <a:gridCol w="457967">
                  <a:extLst>
                    <a:ext uri="{9D8B030D-6E8A-4147-A177-3AD203B41FA5}">
                      <a16:colId xmlns:a16="http://schemas.microsoft.com/office/drawing/2014/main" val="3823153692"/>
                    </a:ext>
                  </a:extLst>
                </a:gridCol>
                <a:gridCol w="502948">
                  <a:extLst>
                    <a:ext uri="{9D8B030D-6E8A-4147-A177-3AD203B41FA5}">
                      <a16:colId xmlns:a16="http://schemas.microsoft.com/office/drawing/2014/main" val="479901079"/>
                    </a:ext>
                  </a:extLst>
                </a:gridCol>
                <a:gridCol w="412987">
                  <a:extLst>
                    <a:ext uri="{9D8B030D-6E8A-4147-A177-3AD203B41FA5}">
                      <a16:colId xmlns:a16="http://schemas.microsoft.com/office/drawing/2014/main" val="2616062064"/>
                    </a:ext>
                  </a:extLst>
                </a:gridCol>
                <a:gridCol w="457967">
                  <a:extLst>
                    <a:ext uri="{9D8B030D-6E8A-4147-A177-3AD203B41FA5}">
                      <a16:colId xmlns:a16="http://schemas.microsoft.com/office/drawing/2014/main" val="1424666195"/>
                    </a:ext>
                  </a:extLst>
                </a:gridCol>
                <a:gridCol w="457967">
                  <a:extLst>
                    <a:ext uri="{9D8B030D-6E8A-4147-A177-3AD203B41FA5}">
                      <a16:colId xmlns:a16="http://schemas.microsoft.com/office/drawing/2014/main" val="1491551211"/>
                    </a:ext>
                  </a:extLst>
                </a:gridCol>
                <a:gridCol w="457967">
                  <a:extLst>
                    <a:ext uri="{9D8B030D-6E8A-4147-A177-3AD203B41FA5}">
                      <a16:colId xmlns:a16="http://schemas.microsoft.com/office/drawing/2014/main" val="1374875091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atures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 Regression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al Network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dom Forest</a:t>
                      </a:r>
                      <a:endParaRPr lang="en-US" sz="700" b="1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7001098"/>
                  </a:ext>
                </a:extLst>
              </a:tr>
              <a:tr h="1100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cision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all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1-score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ort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cision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all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1-score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ort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cision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all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1-score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ort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extLst>
                  <a:ext uri="{0D108BD9-81ED-4DB2-BD59-A6C34878D82A}">
                    <a16:rowId xmlns:a16="http://schemas.microsoft.com/office/drawing/2014/main" val="1345927283"/>
                  </a:ext>
                </a:extLst>
              </a:tr>
              <a:tr h="1100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extLst>
                  <a:ext uri="{0D108BD9-81ED-4DB2-BD59-A6C34878D82A}">
                    <a16:rowId xmlns:a16="http://schemas.microsoft.com/office/drawing/2014/main" val="1359915779"/>
                  </a:ext>
                </a:extLst>
              </a:tr>
              <a:tr h="1100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extLst>
                  <a:ext uri="{0D108BD9-81ED-4DB2-BD59-A6C34878D82A}">
                    <a16:rowId xmlns:a16="http://schemas.microsoft.com/office/drawing/2014/main" val="1377637944"/>
                  </a:ext>
                </a:extLst>
              </a:tr>
              <a:tr h="1100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uracy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extLst>
                  <a:ext uri="{0D108BD9-81ED-4DB2-BD59-A6C34878D82A}">
                    <a16:rowId xmlns:a16="http://schemas.microsoft.com/office/drawing/2014/main" val="2045512022"/>
                  </a:ext>
                </a:extLst>
              </a:tr>
              <a:tr h="1100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ro avg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extLst>
                  <a:ext uri="{0D108BD9-81ED-4DB2-BD59-A6C34878D82A}">
                    <a16:rowId xmlns:a16="http://schemas.microsoft.com/office/drawing/2014/main" val="2759640645"/>
                  </a:ext>
                </a:extLst>
              </a:tr>
              <a:tr h="1100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ighted avg</a:t>
                      </a:r>
                      <a:endParaRPr lang="en-US" sz="7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lang="en-US" sz="7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u="none" strike="noStrike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</a:t>
                      </a:r>
                      <a:endParaRPr lang="en-US" sz="7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8" marR="5158" marT="5158" marB="0" anchor="ctr"/>
                </a:tc>
                <a:extLst>
                  <a:ext uri="{0D108BD9-81ED-4DB2-BD59-A6C34878D82A}">
                    <a16:rowId xmlns:a16="http://schemas.microsoft.com/office/drawing/2014/main" val="315667571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1889709-697A-27FE-8136-D84442C4E7A2}"/>
              </a:ext>
            </a:extLst>
          </p:cNvPr>
          <p:cNvSpPr txBox="1"/>
          <p:nvPr/>
        </p:nvSpPr>
        <p:spPr>
          <a:xfrm>
            <a:off x="354329" y="2759529"/>
            <a:ext cx="61493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6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rformance metrics of Machine Learning Models in benign vs cancer of colon cancer patients using TCG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ataset.</a:t>
            </a:r>
          </a:p>
        </p:txBody>
      </p:sp>
    </p:spTree>
    <p:extLst>
      <p:ext uri="{BB962C8B-B14F-4D97-AF65-F5344CB8AC3E}">
        <p14:creationId xmlns:p14="http://schemas.microsoft.com/office/powerpoint/2010/main" val="2445749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2</TotalTime>
  <Words>109</Words>
  <Application>Microsoft Macintosh PowerPoint</Application>
  <PresentationFormat>A4 Paper (210x297 mm)</PresentationFormat>
  <Paragraphs>8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mal, Abu Hena Mostafa</dc:creator>
  <cp:lastModifiedBy>Kamal, Abu Hena Mostafa</cp:lastModifiedBy>
  <cp:revision>2</cp:revision>
  <dcterms:created xsi:type="dcterms:W3CDTF">2025-01-08T23:26:26Z</dcterms:created>
  <dcterms:modified xsi:type="dcterms:W3CDTF">2025-02-22T20:53:49Z</dcterms:modified>
</cp:coreProperties>
</file>